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700"/>
  </p:normalViewPr>
  <p:slideViewPr>
    <p:cSldViewPr snapToGrid="0" snapToObjects="1">
      <p:cViewPr>
        <p:scale>
          <a:sx n="283" d="100"/>
          <a:sy n="283" d="100"/>
        </p:scale>
        <p:origin x="144" y="-118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0117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5345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0436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4292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985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2849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06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37028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86160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4724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4726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62BF23-E7F2-EF48-9727-B674A6878316}" type="datetimeFigureOut">
              <a:rPr lang="es-ES" smtClean="0"/>
              <a:t>29/12/23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381A5D-4076-5347-9661-2CEDC3D67498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2805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uadroTexto 34"/>
          <p:cNvSpPr txBox="1"/>
          <p:nvPr/>
        </p:nvSpPr>
        <p:spPr>
          <a:xfrm>
            <a:off x="926188" y="8019240"/>
            <a:ext cx="51815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900" b="1">
                <a:latin typeface="Times New Roman"/>
                <a:cs typeface="Times New Roman"/>
              </a:rPr>
              <a:t>Fig. </a:t>
            </a:r>
            <a:r>
              <a:rPr lang="es-ES" sz="900" b="1" dirty="0">
                <a:latin typeface="Times New Roman"/>
                <a:cs typeface="Times New Roman"/>
              </a:rPr>
              <a:t>S5. </a:t>
            </a:r>
            <a:r>
              <a:rPr lang="es-ES" sz="900" b="1" dirty="0" err="1">
                <a:latin typeface="Times New Roman"/>
                <a:cs typeface="Times New Roman"/>
              </a:rPr>
              <a:t>Model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structures</a:t>
            </a:r>
            <a:r>
              <a:rPr lang="es-ES" sz="900" b="1" dirty="0">
                <a:latin typeface="Times New Roman"/>
                <a:cs typeface="Times New Roman"/>
              </a:rPr>
              <a:t> of </a:t>
            </a:r>
            <a:r>
              <a:rPr lang="es-ES" sz="900" b="1" dirty="0" err="1">
                <a:latin typeface="Times New Roman"/>
                <a:cs typeface="Times New Roman"/>
              </a:rPr>
              <a:t>ZepA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from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species</a:t>
            </a:r>
            <a:r>
              <a:rPr lang="es-ES" sz="900" b="1" dirty="0">
                <a:latin typeface="Times New Roman"/>
                <a:cs typeface="Times New Roman"/>
              </a:rPr>
              <a:t> of </a:t>
            </a:r>
            <a:r>
              <a:rPr lang="es-ES" sz="900" b="1" dirty="0" err="1">
                <a:latin typeface="Times New Roman"/>
                <a:cs typeface="Times New Roman"/>
              </a:rPr>
              <a:t>distinct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bacterial</a:t>
            </a:r>
            <a:r>
              <a:rPr lang="es-ES" sz="900" b="1" dirty="0">
                <a:latin typeface="Times New Roman"/>
                <a:cs typeface="Times New Roman"/>
              </a:rPr>
              <a:t> </a:t>
            </a:r>
            <a:r>
              <a:rPr lang="es-ES" sz="900" b="1" dirty="0" err="1">
                <a:latin typeface="Times New Roman"/>
                <a:cs typeface="Times New Roman"/>
              </a:rPr>
              <a:t>phyla</a:t>
            </a:r>
            <a:r>
              <a:rPr lang="es-ES" sz="900" b="1" dirty="0">
                <a:latin typeface="Times New Roman"/>
                <a:cs typeface="Times New Roman"/>
              </a:rPr>
              <a:t>. </a:t>
            </a:r>
            <a:r>
              <a:rPr lang="es-ES" sz="900" dirty="0">
                <a:latin typeface="Times New Roman"/>
                <a:cs typeface="Times New Roman"/>
              </a:rPr>
              <a:t>(A) </a:t>
            </a:r>
            <a:r>
              <a:rPr lang="es-ES" sz="900" dirty="0" err="1">
                <a:latin typeface="Times New Roman"/>
                <a:cs typeface="Times New Roman"/>
              </a:rPr>
              <a:t>Structural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model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for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ZepA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protein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from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indicat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organism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wer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built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using</a:t>
            </a:r>
            <a:r>
              <a:rPr lang="es-ES" sz="900" dirty="0">
                <a:latin typeface="Times New Roman"/>
                <a:cs typeface="Times New Roman"/>
              </a:rPr>
              <a:t> AlphaFold2 and are </a:t>
            </a:r>
            <a:r>
              <a:rPr lang="es-ES" sz="900" dirty="0" err="1">
                <a:latin typeface="Times New Roman"/>
                <a:cs typeface="Times New Roman"/>
              </a:rPr>
              <a:t>shown</a:t>
            </a:r>
            <a:r>
              <a:rPr lang="es-ES" sz="900" dirty="0">
                <a:latin typeface="Times New Roman"/>
                <a:cs typeface="Times New Roman"/>
              </a:rPr>
              <a:t>. (B) </a:t>
            </a:r>
            <a:r>
              <a:rPr lang="es-ES" sz="900" dirty="0" err="1">
                <a:latin typeface="Times New Roman"/>
                <a:cs typeface="Times New Roman"/>
              </a:rPr>
              <a:t>Structural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model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wer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aligned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with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Pymol</a:t>
            </a:r>
            <a:r>
              <a:rPr lang="es-ES" sz="900" dirty="0">
                <a:latin typeface="Times New Roman"/>
                <a:cs typeface="Times New Roman"/>
              </a:rPr>
              <a:t> v 1.7.6.3 and are </a:t>
            </a:r>
            <a:r>
              <a:rPr lang="es-ES" sz="900" dirty="0" err="1">
                <a:latin typeface="Times New Roman"/>
                <a:cs typeface="Times New Roman"/>
              </a:rPr>
              <a:t>shown</a:t>
            </a:r>
            <a:r>
              <a:rPr lang="es-ES" sz="900" dirty="0">
                <a:latin typeface="Times New Roman"/>
                <a:cs typeface="Times New Roman"/>
              </a:rPr>
              <a:t> in </a:t>
            </a:r>
            <a:r>
              <a:rPr lang="es-ES" sz="900" dirty="0" err="1">
                <a:latin typeface="Times New Roman"/>
                <a:cs typeface="Times New Roman"/>
              </a:rPr>
              <a:t>different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orientations</a:t>
            </a:r>
            <a:r>
              <a:rPr lang="es-ES" sz="900" dirty="0">
                <a:latin typeface="Times New Roman"/>
                <a:cs typeface="Times New Roman"/>
              </a:rPr>
              <a:t>. (C) </a:t>
            </a:r>
            <a:r>
              <a:rPr lang="es-ES" sz="900" dirty="0" err="1">
                <a:latin typeface="Times New Roman"/>
                <a:cs typeface="Times New Roman"/>
              </a:rPr>
              <a:t>Clos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view</a:t>
            </a:r>
            <a:r>
              <a:rPr lang="es-ES" sz="900" dirty="0">
                <a:latin typeface="Times New Roman"/>
                <a:cs typeface="Times New Roman"/>
              </a:rPr>
              <a:t> of </a:t>
            </a:r>
            <a:r>
              <a:rPr lang="es-ES" sz="900" dirty="0" err="1">
                <a:latin typeface="Times New Roman"/>
                <a:cs typeface="Times New Roman"/>
              </a:rPr>
              <a:t>the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i="1" dirty="0" err="1">
                <a:latin typeface="Times New Roman"/>
                <a:cs typeface="Times New Roman"/>
              </a:rPr>
              <a:t>Anabaena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ZepA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model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showing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residues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putatively</a:t>
            </a:r>
            <a:r>
              <a:rPr lang="es-ES" sz="900" dirty="0">
                <a:latin typeface="Times New Roman"/>
                <a:cs typeface="Times New Roman"/>
              </a:rPr>
              <a:t> </a:t>
            </a:r>
            <a:r>
              <a:rPr lang="es-ES" sz="900" dirty="0" err="1">
                <a:latin typeface="Times New Roman"/>
                <a:cs typeface="Times New Roman"/>
              </a:rPr>
              <a:t>involved</a:t>
            </a:r>
            <a:r>
              <a:rPr lang="es-ES" sz="900" dirty="0">
                <a:latin typeface="Times New Roman"/>
                <a:cs typeface="Times New Roman"/>
              </a:rPr>
              <a:t> in zinc </a:t>
            </a:r>
            <a:r>
              <a:rPr lang="es-ES" sz="900" dirty="0" err="1">
                <a:latin typeface="Times New Roman"/>
                <a:cs typeface="Times New Roman"/>
              </a:rPr>
              <a:t>coordination</a:t>
            </a:r>
            <a:r>
              <a:rPr lang="es-ES" sz="900" dirty="0">
                <a:latin typeface="Times New Roman"/>
                <a:cs typeface="Times New Roman"/>
              </a:rPr>
              <a:t>.</a:t>
            </a:r>
            <a:endParaRPr lang="es-ES" sz="900" b="1" dirty="0">
              <a:solidFill>
                <a:srgbClr val="FF0000"/>
              </a:solidFill>
              <a:latin typeface="Times New Roman"/>
              <a:cs typeface="Times New Roman"/>
            </a:endParaRPr>
          </a:p>
        </p:txBody>
      </p:sp>
      <p:grpSp>
        <p:nvGrpSpPr>
          <p:cNvPr id="43" name="Agrupar 42"/>
          <p:cNvGrpSpPr/>
          <p:nvPr/>
        </p:nvGrpSpPr>
        <p:grpSpPr>
          <a:xfrm>
            <a:off x="1228592" y="1104034"/>
            <a:ext cx="4540968" cy="6556678"/>
            <a:chOff x="1332705" y="2152779"/>
            <a:chExt cx="4540968" cy="6556678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296" t="12857" r="19206"/>
            <a:stretch/>
          </p:blipFill>
          <p:spPr>
            <a:xfrm>
              <a:off x="1758950" y="2214308"/>
              <a:ext cx="763260" cy="810582"/>
            </a:xfrm>
            <a:prstGeom prst="rect">
              <a:avLst/>
            </a:prstGeom>
          </p:spPr>
        </p:pic>
        <p:pic>
          <p:nvPicPr>
            <p:cNvPr id="5" name="Imagen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745975" y="2214308"/>
              <a:ext cx="717551" cy="810582"/>
            </a:xfrm>
            <a:prstGeom prst="rect">
              <a:avLst/>
            </a:prstGeom>
          </p:spPr>
        </p:pic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73" t="17408" r="19447"/>
            <a:stretch/>
          </p:blipFill>
          <p:spPr>
            <a:xfrm>
              <a:off x="3687291" y="2235475"/>
              <a:ext cx="711201" cy="768249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779" t="11264" r="20348"/>
            <a:stretch/>
          </p:blipFill>
          <p:spPr>
            <a:xfrm>
              <a:off x="4622258" y="2206900"/>
              <a:ext cx="698500" cy="825399"/>
            </a:xfrm>
            <a:prstGeom prst="rect">
              <a:avLst/>
            </a:prstGeom>
          </p:spPr>
        </p:pic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625114" y="3879139"/>
              <a:ext cx="1249310" cy="1365612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7"/>
            <a:srcRect l="30288" t="3698" r="22748"/>
            <a:stretch/>
          </p:blipFill>
          <p:spPr>
            <a:xfrm>
              <a:off x="1511688" y="5642477"/>
              <a:ext cx="1427163" cy="1597751"/>
            </a:xfrm>
            <a:prstGeom prst="rect">
              <a:avLst/>
            </a:prstGeom>
          </p:spPr>
        </p:pic>
        <p:pic>
          <p:nvPicPr>
            <p:cNvPr id="10" name="Imagen 9"/>
            <p:cNvPicPr>
              <a:picLocks noChangeAspect="1"/>
            </p:cNvPicPr>
            <p:nvPr/>
          </p:nvPicPr>
          <p:blipFill rotWithShape="1">
            <a:blip r:embed="rId8">
              <a:alphaModFix/>
            </a:blip>
            <a:srcRect l="23309" t="10422" r="18587" b="6217"/>
            <a:stretch/>
          </p:blipFill>
          <p:spPr>
            <a:xfrm>
              <a:off x="4127888" y="3877983"/>
              <a:ext cx="1745785" cy="1367422"/>
            </a:xfrm>
            <a:prstGeom prst="rect">
              <a:avLst/>
            </a:prstGeom>
          </p:spPr>
        </p:pic>
        <p:grpSp>
          <p:nvGrpSpPr>
            <p:cNvPr id="11" name="Agrupar 10"/>
            <p:cNvGrpSpPr/>
            <p:nvPr/>
          </p:nvGrpSpPr>
          <p:grpSpPr>
            <a:xfrm>
              <a:off x="2769933" y="4227914"/>
              <a:ext cx="1174755" cy="517525"/>
              <a:chOff x="2952750" y="2414238"/>
              <a:chExt cx="1174755" cy="517525"/>
            </a:xfrm>
          </p:grpSpPr>
          <p:grpSp>
            <p:nvGrpSpPr>
              <p:cNvPr id="12" name="Agrupar 11"/>
              <p:cNvGrpSpPr/>
              <p:nvPr/>
            </p:nvGrpSpPr>
            <p:grpSpPr>
              <a:xfrm>
                <a:off x="3437341" y="2414238"/>
                <a:ext cx="514784" cy="377825"/>
                <a:chOff x="3259541" y="2414238"/>
                <a:chExt cx="514784" cy="377825"/>
              </a:xfrm>
            </p:grpSpPr>
            <p:grpSp>
              <p:nvGrpSpPr>
                <p:cNvPr id="14" name="Agrupar 13"/>
                <p:cNvGrpSpPr/>
                <p:nvPr/>
              </p:nvGrpSpPr>
              <p:grpSpPr>
                <a:xfrm>
                  <a:off x="3259541" y="2414238"/>
                  <a:ext cx="242010" cy="377825"/>
                  <a:chOff x="3500836" y="3686175"/>
                  <a:chExt cx="242010" cy="377825"/>
                </a:xfrm>
              </p:grpSpPr>
              <p:grpSp>
                <p:nvGrpSpPr>
                  <p:cNvPr id="16" name="Agrupar 15"/>
                  <p:cNvGrpSpPr/>
                  <p:nvPr/>
                </p:nvGrpSpPr>
                <p:grpSpPr>
                  <a:xfrm flipH="1" flipV="1">
                    <a:off x="3500836" y="3808205"/>
                    <a:ext cx="242010" cy="113135"/>
                    <a:chOff x="4516833" y="5651500"/>
                    <a:chExt cx="1027011" cy="339725"/>
                  </a:xfrm>
                </p:grpSpPr>
                <p:sp>
                  <p:nvSpPr>
                    <p:cNvPr id="18" name="Forma libre 17"/>
                    <p:cNvSpPr/>
                    <p:nvPr/>
                  </p:nvSpPr>
                  <p:spPr>
                    <a:xfrm rot="21404975" flipH="1">
                      <a:off x="5034358" y="5651500"/>
                      <a:ext cx="509486" cy="279400"/>
                    </a:xfrm>
                    <a:custGeom>
                      <a:avLst/>
                      <a:gdLst>
                        <a:gd name="connsiteX0" fmla="*/ 20243 w 515543"/>
                        <a:gd name="connsiteY0" fmla="*/ 292204 h 292204"/>
                        <a:gd name="connsiteX1" fmla="*/ 7543 w 515543"/>
                        <a:gd name="connsiteY1" fmla="*/ 190604 h 292204"/>
                        <a:gd name="connsiteX2" fmla="*/ 121843 w 515543"/>
                        <a:gd name="connsiteY2" fmla="*/ 89004 h 292204"/>
                        <a:gd name="connsiteX3" fmla="*/ 312343 w 515543"/>
                        <a:gd name="connsiteY3" fmla="*/ 12804 h 292204"/>
                        <a:gd name="connsiteX4" fmla="*/ 515543 w 515543"/>
                        <a:gd name="connsiteY4" fmla="*/ 104 h 292204"/>
                        <a:gd name="connsiteX0" fmla="*/ 64351 w 508851"/>
                        <a:gd name="connsiteY0" fmla="*/ 279504 h 279504"/>
                        <a:gd name="connsiteX1" fmla="*/ 851 w 508851"/>
                        <a:gd name="connsiteY1" fmla="*/ 190604 h 279504"/>
                        <a:gd name="connsiteX2" fmla="*/ 115151 w 508851"/>
                        <a:gd name="connsiteY2" fmla="*/ 89004 h 279504"/>
                        <a:gd name="connsiteX3" fmla="*/ 305651 w 508851"/>
                        <a:gd name="connsiteY3" fmla="*/ 12804 h 279504"/>
                        <a:gd name="connsiteX4" fmla="*/ 508851 w 508851"/>
                        <a:gd name="connsiteY4" fmla="*/ 104 h 279504"/>
                        <a:gd name="connsiteX0" fmla="*/ 64986 w 509486"/>
                        <a:gd name="connsiteY0" fmla="*/ 279504 h 279504"/>
                        <a:gd name="connsiteX1" fmla="*/ 1486 w 509486"/>
                        <a:gd name="connsiteY1" fmla="*/ 190604 h 279504"/>
                        <a:gd name="connsiteX2" fmla="*/ 115786 w 509486"/>
                        <a:gd name="connsiteY2" fmla="*/ 89004 h 279504"/>
                        <a:gd name="connsiteX3" fmla="*/ 306286 w 509486"/>
                        <a:gd name="connsiteY3" fmla="*/ 12804 h 279504"/>
                        <a:gd name="connsiteX4" fmla="*/ 509486 w 509486"/>
                        <a:gd name="connsiteY4" fmla="*/ 104 h 279504"/>
                        <a:gd name="connsiteX0" fmla="*/ 64986 w 509486"/>
                        <a:gd name="connsiteY0" fmla="*/ 279400 h 279400"/>
                        <a:gd name="connsiteX1" fmla="*/ 1486 w 509486"/>
                        <a:gd name="connsiteY1" fmla="*/ 190500 h 279400"/>
                        <a:gd name="connsiteX2" fmla="*/ 115786 w 509486"/>
                        <a:gd name="connsiteY2" fmla="*/ 88900 h 279400"/>
                        <a:gd name="connsiteX3" fmla="*/ 306286 w 509486"/>
                        <a:gd name="connsiteY3" fmla="*/ 22225 h 279400"/>
                        <a:gd name="connsiteX4" fmla="*/ 509486 w 509486"/>
                        <a:gd name="connsiteY4" fmla="*/ 0 h 279400"/>
                        <a:gd name="connsiteX0" fmla="*/ 64986 w 509486"/>
                        <a:gd name="connsiteY0" fmla="*/ 267053 h 267053"/>
                        <a:gd name="connsiteX1" fmla="*/ 1486 w 509486"/>
                        <a:gd name="connsiteY1" fmla="*/ 178153 h 267053"/>
                        <a:gd name="connsiteX2" fmla="*/ 115786 w 509486"/>
                        <a:gd name="connsiteY2" fmla="*/ 76553 h 267053"/>
                        <a:gd name="connsiteX3" fmla="*/ 306286 w 509486"/>
                        <a:gd name="connsiteY3" fmla="*/ 9878 h 267053"/>
                        <a:gd name="connsiteX4" fmla="*/ 509486 w 509486"/>
                        <a:gd name="connsiteY4" fmla="*/ 353 h 267053"/>
                        <a:gd name="connsiteX0" fmla="*/ 64986 w 509486"/>
                        <a:gd name="connsiteY0" fmla="*/ 279400 h 279400"/>
                        <a:gd name="connsiteX1" fmla="*/ 1486 w 509486"/>
                        <a:gd name="connsiteY1" fmla="*/ 190500 h 279400"/>
                        <a:gd name="connsiteX2" fmla="*/ 115786 w 509486"/>
                        <a:gd name="connsiteY2" fmla="*/ 88900 h 279400"/>
                        <a:gd name="connsiteX3" fmla="*/ 306286 w 509486"/>
                        <a:gd name="connsiteY3" fmla="*/ 22225 h 279400"/>
                        <a:gd name="connsiteX4" fmla="*/ 509486 w 509486"/>
                        <a:gd name="connsiteY4" fmla="*/ 0 h 2794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509486" h="279400">
                          <a:moveTo>
                            <a:pt x="64986" y="279400"/>
                          </a:moveTo>
                          <a:cubicBezTo>
                            <a:pt x="21594" y="258233"/>
                            <a:pt x="-6981" y="222250"/>
                            <a:pt x="1486" y="190500"/>
                          </a:cubicBezTo>
                          <a:cubicBezTo>
                            <a:pt x="9953" y="158750"/>
                            <a:pt x="64986" y="116946"/>
                            <a:pt x="115786" y="88900"/>
                          </a:cubicBezTo>
                          <a:cubicBezTo>
                            <a:pt x="166586" y="60854"/>
                            <a:pt x="240669" y="37042"/>
                            <a:pt x="306286" y="22225"/>
                          </a:cubicBezTo>
                          <a:cubicBezTo>
                            <a:pt x="371903" y="7408"/>
                            <a:pt x="509486" y="0"/>
                            <a:pt x="509486" y="0"/>
                          </a:cubicBezTo>
                        </a:path>
                      </a:pathLst>
                    </a:custGeom>
                    <a:ln w="6350" cmpd="sng">
                      <a:solidFill>
                        <a:schemeClr val="tx1"/>
                      </a:solidFill>
                      <a:tailEnd w="sm" len="med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s-ES"/>
                    </a:p>
                  </p:txBody>
                </p:sp>
                <p:sp>
                  <p:nvSpPr>
                    <p:cNvPr id="19" name="Forma libre 18"/>
                    <p:cNvSpPr/>
                    <p:nvPr/>
                  </p:nvSpPr>
                  <p:spPr>
                    <a:xfrm>
                      <a:off x="4559300" y="5911850"/>
                      <a:ext cx="250825" cy="79375"/>
                    </a:xfrm>
                    <a:custGeom>
                      <a:avLst/>
                      <a:gdLst>
                        <a:gd name="connsiteX0" fmla="*/ 0 w 250825"/>
                        <a:gd name="connsiteY0" fmla="*/ 0 h 79375"/>
                        <a:gd name="connsiteX1" fmla="*/ 117475 w 250825"/>
                        <a:gd name="connsiteY1" fmla="*/ 53975 h 79375"/>
                        <a:gd name="connsiteX2" fmla="*/ 250825 w 250825"/>
                        <a:gd name="connsiteY2" fmla="*/ 79375 h 79375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</a:cxnLst>
                      <a:rect l="l" t="t" r="r" b="b"/>
                      <a:pathLst>
                        <a:path w="250825" h="79375">
                          <a:moveTo>
                            <a:pt x="0" y="0"/>
                          </a:moveTo>
                          <a:cubicBezTo>
                            <a:pt x="37835" y="20373"/>
                            <a:pt x="75671" y="40746"/>
                            <a:pt x="117475" y="53975"/>
                          </a:cubicBezTo>
                          <a:cubicBezTo>
                            <a:pt x="159279" y="67204"/>
                            <a:pt x="250825" y="79375"/>
                            <a:pt x="250825" y="79375"/>
                          </a:cubicBezTo>
                        </a:path>
                      </a:pathLst>
                    </a:custGeom>
                    <a:ln w="6350" cmpd="sng">
                      <a:solidFill>
                        <a:srgbClr val="000000"/>
                      </a:solidFill>
                      <a:headEnd type="none"/>
                      <a:tailEnd type="triangle" w="sm" len="sm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s-ES"/>
                    </a:p>
                  </p:txBody>
                </p:sp>
                <p:sp>
                  <p:nvSpPr>
                    <p:cNvPr id="20" name="Forma libre 19"/>
                    <p:cNvSpPr/>
                    <p:nvPr/>
                  </p:nvSpPr>
                  <p:spPr>
                    <a:xfrm rot="195025">
                      <a:off x="4516833" y="5651500"/>
                      <a:ext cx="509486" cy="279400"/>
                    </a:xfrm>
                    <a:custGeom>
                      <a:avLst/>
                      <a:gdLst>
                        <a:gd name="connsiteX0" fmla="*/ 20243 w 515543"/>
                        <a:gd name="connsiteY0" fmla="*/ 292204 h 292204"/>
                        <a:gd name="connsiteX1" fmla="*/ 7543 w 515543"/>
                        <a:gd name="connsiteY1" fmla="*/ 190604 h 292204"/>
                        <a:gd name="connsiteX2" fmla="*/ 121843 w 515543"/>
                        <a:gd name="connsiteY2" fmla="*/ 89004 h 292204"/>
                        <a:gd name="connsiteX3" fmla="*/ 312343 w 515543"/>
                        <a:gd name="connsiteY3" fmla="*/ 12804 h 292204"/>
                        <a:gd name="connsiteX4" fmla="*/ 515543 w 515543"/>
                        <a:gd name="connsiteY4" fmla="*/ 104 h 292204"/>
                        <a:gd name="connsiteX0" fmla="*/ 64351 w 508851"/>
                        <a:gd name="connsiteY0" fmla="*/ 279504 h 279504"/>
                        <a:gd name="connsiteX1" fmla="*/ 851 w 508851"/>
                        <a:gd name="connsiteY1" fmla="*/ 190604 h 279504"/>
                        <a:gd name="connsiteX2" fmla="*/ 115151 w 508851"/>
                        <a:gd name="connsiteY2" fmla="*/ 89004 h 279504"/>
                        <a:gd name="connsiteX3" fmla="*/ 305651 w 508851"/>
                        <a:gd name="connsiteY3" fmla="*/ 12804 h 279504"/>
                        <a:gd name="connsiteX4" fmla="*/ 508851 w 508851"/>
                        <a:gd name="connsiteY4" fmla="*/ 104 h 279504"/>
                        <a:gd name="connsiteX0" fmla="*/ 64986 w 509486"/>
                        <a:gd name="connsiteY0" fmla="*/ 279504 h 279504"/>
                        <a:gd name="connsiteX1" fmla="*/ 1486 w 509486"/>
                        <a:gd name="connsiteY1" fmla="*/ 190604 h 279504"/>
                        <a:gd name="connsiteX2" fmla="*/ 115786 w 509486"/>
                        <a:gd name="connsiteY2" fmla="*/ 89004 h 279504"/>
                        <a:gd name="connsiteX3" fmla="*/ 306286 w 509486"/>
                        <a:gd name="connsiteY3" fmla="*/ 12804 h 279504"/>
                        <a:gd name="connsiteX4" fmla="*/ 509486 w 509486"/>
                        <a:gd name="connsiteY4" fmla="*/ 104 h 279504"/>
                        <a:gd name="connsiteX0" fmla="*/ 64986 w 509486"/>
                        <a:gd name="connsiteY0" fmla="*/ 279400 h 279400"/>
                        <a:gd name="connsiteX1" fmla="*/ 1486 w 509486"/>
                        <a:gd name="connsiteY1" fmla="*/ 190500 h 279400"/>
                        <a:gd name="connsiteX2" fmla="*/ 115786 w 509486"/>
                        <a:gd name="connsiteY2" fmla="*/ 88900 h 279400"/>
                        <a:gd name="connsiteX3" fmla="*/ 306286 w 509486"/>
                        <a:gd name="connsiteY3" fmla="*/ 22225 h 279400"/>
                        <a:gd name="connsiteX4" fmla="*/ 509486 w 509486"/>
                        <a:gd name="connsiteY4" fmla="*/ 0 h 279400"/>
                        <a:gd name="connsiteX0" fmla="*/ 64986 w 509486"/>
                        <a:gd name="connsiteY0" fmla="*/ 267053 h 267053"/>
                        <a:gd name="connsiteX1" fmla="*/ 1486 w 509486"/>
                        <a:gd name="connsiteY1" fmla="*/ 178153 h 267053"/>
                        <a:gd name="connsiteX2" fmla="*/ 115786 w 509486"/>
                        <a:gd name="connsiteY2" fmla="*/ 76553 h 267053"/>
                        <a:gd name="connsiteX3" fmla="*/ 306286 w 509486"/>
                        <a:gd name="connsiteY3" fmla="*/ 9878 h 267053"/>
                        <a:gd name="connsiteX4" fmla="*/ 509486 w 509486"/>
                        <a:gd name="connsiteY4" fmla="*/ 353 h 267053"/>
                        <a:gd name="connsiteX0" fmla="*/ 64986 w 509486"/>
                        <a:gd name="connsiteY0" fmla="*/ 279400 h 279400"/>
                        <a:gd name="connsiteX1" fmla="*/ 1486 w 509486"/>
                        <a:gd name="connsiteY1" fmla="*/ 190500 h 279400"/>
                        <a:gd name="connsiteX2" fmla="*/ 115786 w 509486"/>
                        <a:gd name="connsiteY2" fmla="*/ 88900 h 279400"/>
                        <a:gd name="connsiteX3" fmla="*/ 306286 w 509486"/>
                        <a:gd name="connsiteY3" fmla="*/ 22225 h 279400"/>
                        <a:gd name="connsiteX4" fmla="*/ 509486 w 509486"/>
                        <a:gd name="connsiteY4" fmla="*/ 0 h 2794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</a:cxnLst>
                      <a:rect l="l" t="t" r="r" b="b"/>
                      <a:pathLst>
                        <a:path w="509486" h="279400">
                          <a:moveTo>
                            <a:pt x="64986" y="279400"/>
                          </a:moveTo>
                          <a:cubicBezTo>
                            <a:pt x="21594" y="258233"/>
                            <a:pt x="-6981" y="222250"/>
                            <a:pt x="1486" y="190500"/>
                          </a:cubicBezTo>
                          <a:cubicBezTo>
                            <a:pt x="9953" y="158750"/>
                            <a:pt x="64986" y="116946"/>
                            <a:pt x="115786" y="88900"/>
                          </a:cubicBezTo>
                          <a:cubicBezTo>
                            <a:pt x="166586" y="60854"/>
                            <a:pt x="240669" y="37042"/>
                            <a:pt x="306286" y="22225"/>
                          </a:cubicBezTo>
                          <a:cubicBezTo>
                            <a:pt x="371903" y="7408"/>
                            <a:pt x="509486" y="0"/>
                            <a:pt x="509486" y="0"/>
                          </a:cubicBezTo>
                        </a:path>
                      </a:pathLst>
                    </a:custGeom>
                    <a:ln w="6350" cmpd="sng">
                      <a:solidFill>
                        <a:schemeClr val="tx1"/>
                      </a:solidFill>
                      <a:tailEnd w="sm" len="med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s-ES"/>
                    </a:p>
                  </p:txBody>
                </p:sp>
              </p:grpSp>
              <p:cxnSp>
                <p:nvCxnSpPr>
                  <p:cNvPr id="17" name="Conector recto 16"/>
                  <p:cNvCxnSpPr/>
                  <p:nvPr/>
                </p:nvCxnSpPr>
                <p:spPr>
                  <a:xfrm>
                    <a:off x="3620774" y="3686175"/>
                    <a:ext cx="2134" cy="377825"/>
                  </a:xfrm>
                  <a:prstGeom prst="line">
                    <a:avLst/>
                  </a:prstGeom>
                  <a:ln w="6350" cmpd="sng">
                    <a:solidFill>
                      <a:srgbClr val="000000"/>
                    </a:solidFill>
                    <a:prstDash val="soli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" name="CuadroTexto 14"/>
                <p:cNvSpPr txBox="1"/>
                <p:nvPr/>
              </p:nvSpPr>
              <p:spPr>
                <a:xfrm>
                  <a:off x="3467105" y="2531713"/>
                  <a:ext cx="30722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/>
                    <a:t>90</a:t>
                  </a:r>
                  <a:r>
                    <a:rPr lang="es-ES" sz="700" baseline="30000" dirty="0"/>
                    <a:t>o</a:t>
                  </a:r>
                  <a:endParaRPr lang="es-ES" sz="700" dirty="0"/>
                </a:p>
              </p:txBody>
            </p:sp>
          </p:grpSp>
          <p:cxnSp>
            <p:nvCxnSpPr>
              <p:cNvPr id="13" name="Conector recto 12"/>
              <p:cNvCxnSpPr/>
              <p:nvPr/>
            </p:nvCxnSpPr>
            <p:spPr>
              <a:xfrm>
                <a:off x="2952750" y="2931763"/>
                <a:ext cx="1174755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1" name="Agrupar 20"/>
            <p:cNvGrpSpPr/>
            <p:nvPr/>
          </p:nvGrpSpPr>
          <p:grpSpPr>
            <a:xfrm>
              <a:off x="2159284" y="5117561"/>
              <a:ext cx="469145" cy="625475"/>
              <a:chOff x="2232030" y="3655661"/>
              <a:chExt cx="469145" cy="625475"/>
            </a:xfrm>
          </p:grpSpPr>
          <p:cxnSp>
            <p:nvCxnSpPr>
              <p:cNvPr id="22" name="Conector recto 21"/>
              <p:cNvCxnSpPr/>
              <p:nvPr/>
            </p:nvCxnSpPr>
            <p:spPr>
              <a:xfrm>
                <a:off x="2232030" y="3776311"/>
                <a:ext cx="0" cy="504825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  <a:headEnd type="none"/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CuadroTexto 22"/>
              <p:cNvSpPr txBox="1"/>
              <p:nvPr/>
            </p:nvSpPr>
            <p:spPr>
              <a:xfrm>
                <a:off x="2393955" y="3655661"/>
                <a:ext cx="30722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/>
                  <a:t>90</a:t>
                </a:r>
                <a:r>
                  <a:rPr lang="es-ES" sz="700" baseline="30000" dirty="0"/>
                  <a:t>o</a:t>
                </a:r>
                <a:endParaRPr lang="es-ES" sz="700" dirty="0"/>
              </a:p>
            </p:txBody>
          </p:sp>
          <p:grpSp>
            <p:nvGrpSpPr>
              <p:cNvPr id="24" name="Agrupar 23"/>
              <p:cNvGrpSpPr/>
              <p:nvPr/>
            </p:nvGrpSpPr>
            <p:grpSpPr>
              <a:xfrm flipV="1">
                <a:off x="2302635" y="3819877"/>
                <a:ext cx="377825" cy="242010"/>
                <a:chOff x="3542996" y="4998683"/>
                <a:chExt cx="377825" cy="242010"/>
              </a:xfrm>
            </p:grpSpPr>
            <p:sp>
              <p:nvSpPr>
                <p:cNvPr id="25" name="Forma libre 24"/>
                <p:cNvSpPr/>
                <p:nvPr/>
              </p:nvSpPr>
              <p:spPr>
                <a:xfrm rot="5204975" flipH="1">
                  <a:off x="3658372" y="5134141"/>
                  <a:ext cx="120058" cy="93046"/>
                </a:xfrm>
                <a:custGeom>
                  <a:avLst/>
                  <a:gdLst>
                    <a:gd name="connsiteX0" fmla="*/ 20243 w 515543"/>
                    <a:gd name="connsiteY0" fmla="*/ 292204 h 292204"/>
                    <a:gd name="connsiteX1" fmla="*/ 7543 w 515543"/>
                    <a:gd name="connsiteY1" fmla="*/ 190604 h 292204"/>
                    <a:gd name="connsiteX2" fmla="*/ 121843 w 515543"/>
                    <a:gd name="connsiteY2" fmla="*/ 89004 h 292204"/>
                    <a:gd name="connsiteX3" fmla="*/ 312343 w 515543"/>
                    <a:gd name="connsiteY3" fmla="*/ 12804 h 292204"/>
                    <a:gd name="connsiteX4" fmla="*/ 515543 w 515543"/>
                    <a:gd name="connsiteY4" fmla="*/ 104 h 292204"/>
                    <a:gd name="connsiteX0" fmla="*/ 64351 w 508851"/>
                    <a:gd name="connsiteY0" fmla="*/ 279504 h 279504"/>
                    <a:gd name="connsiteX1" fmla="*/ 851 w 508851"/>
                    <a:gd name="connsiteY1" fmla="*/ 190604 h 279504"/>
                    <a:gd name="connsiteX2" fmla="*/ 115151 w 508851"/>
                    <a:gd name="connsiteY2" fmla="*/ 89004 h 279504"/>
                    <a:gd name="connsiteX3" fmla="*/ 305651 w 508851"/>
                    <a:gd name="connsiteY3" fmla="*/ 12804 h 279504"/>
                    <a:gd name="connsiteX4" fmla="*/ 508851 w 508851"/>
                    <a:gd name="connsiteY4" fmla="*/ 104 h 279504"/>
                    <a:gd name="connsiteX0" fmla="*/ 64986 w 509486"/>
                    <a:gd name="connsiteY0" fmla="*/ 279504 h 279504"/>
                    <a:gd name="connsiteX1" fmla="*/ 1486 w 509486"/>
                    <a:gd name="connsiteY1" fmla="*/ 190604 h 279504"/>
                    <a:gd name="connsiteX2" fmla="*/ 115786 w 509486"/>
                    <a:gd name="connsiteY2" fmla="*/ 89004 h 279504"/>
                    <a:gd name="connsiteX3" fmla="*/ 306286 w 509486"/>
                    <a:gd name="connsiteY3" fmla="*/ 12804 h 279504"/>
                    <a:gd name="connsiteX4" fmla="*/ 509486 w 509486"/>
                    <a:gd name="connsiteY4" fmla="*/ 104 h 279504"/>
                    <a:gd name="connsiteX0" fmla="*/ 64986 w 509486"/>
                    <a:gd name="connsiteY0" fmla="*/ 279400 h 279400"/>
                    <a:gd name="connsiteX1" fmla="*/ 1486 w 509486"/>
                    <a:gd name="connsiteY1" fmla="*/ 190500 h 279400"/>
                    <a:gd name="connsiteX2" fmla="*/ 115786 w 509486"/>
                    <a:gd name="connsiteY2" fmla="*/ 88900 h 279400"/>
                    <a:gd name="connsiteX3" fmla="*/ 306286 w 509486"/>
                    <a:gd name="connsiteY3" fmla="*/ 22225 h 279400"/>
                    <a:gd name="connsiteX4" fmla="*/ 509486 w 509486"/>
                    <a:gd name="connsiteY4" fmla="*/ 0 h 279400"/>
                    <a:gd name="connsiteX0" fmla="*/ 64986 w 509486"/>
                    <a:gd name="connsiteY0" fmla="*/ 267053 h 267053"/>
                    <a:gd name="connsiteX1" fmla="*/ 1486 w 509486"/>
                    <a:gd name="connsiteY1" fmla="*/ 178153 h 267053"/>
                    <a:gd name="connsiteX2" fmla="*/ 115786 w 509486"/>
                    <a:gd name="connsiteY2" fmla="*/ 76553 h 267053"/>
                    <a:gd name="connsiteX3" fmla="*/ 306286 w 509486"/>
                    <a:gd name="connsiteY3" fmla="*/ 9878 h 267053"/>
                    <a:gd name="connsiteX4" fmla="*/ 509486 w 509486"/>
                    <a:gd name="connsiteY4" fmla="*/ 353 h 267053"/>
                    <a:gd name="connsiteX0" fmla="*/ 64986 w 509486"/>
                    <a:gd name="connsiteY0" fmla="*/ 279400 h 279400"/>
                    <a:gd name="connsiteX1" fmla="*/ 1486 w 509486"/>
                    <a:gd name="connsiteY1" fmla="*/ 190500 h 279400"/>
                    <a:gd name="connsiteX2" fmla="*/ 115786 w 509486"/>
                    <a:gd name="connsiteY2" fmla="*/ 88900 h 279400"/>
                    <a:gd name="connsiteX3" fmla="*/ 306286 w 509486"/>
                    <a:gd name="connsiteY3" fmla="*/ 22225 h 279400"/>
                    <a:gd name="connsiteX4" fmla="*/ 509486 w 509486"/>
                    <a:gd name="connsiteY4" fmla="*/ 0 h 279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509486" h="279400">
                      <a:moveTo>
                        <a:pt x="64986" y="279400"/>
                      </a:moveTo>
                      <a:cubicBezTo>
                        <a:pt x="21594" y="258233"/>
                        <a:pt x="-6981" y="222250"/>
                        <a:pt x="1486" y="190500"/>
                      </a:cubicBezTo>
                      <a:cubicBezTo>
                        <a:pt x="9953" y="158750"/>
                        <a:pt x="64986" y="116946"/>
                        <a:pt x="115786" y="88900"/>
                      </a:cubicBezTo>
                      <a:cubicBezTo>
                        <a:pt x="166586" y="60854"/>
                        <a:pt x="240669" y="37042"/>
                        <a:pt x="306286" y="22225"/>
                      </a:cubicBezTo>
                      <a:cubicBezTo>
                        <a:pt x="371903" y="7408"/>
                        <a:pt x="509486" y="0"/>
                        <a:pt x="509486" y="0"/>
                      </a:cubicBezTo>
                    </a:path>
                  </a:pathLst>
                </a:custGeom>
                <a:ln w="6350" cmpd="sng">
                  <a:solidFill>
                    <a:schemeClr val="tx1"/>
                  </a:solidFill>
                  <a:tailEnd w="sm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6" name="Forma libre 25"/>
                <p:cNvSpPr/>
                <p:nvPr/>
              </p:nvSpPr>
              <p:spPr>
                <a:xfrm rot="5400000">
                  <a:off x="3635452" y="5025026"/>
                  <a:ext cx="59106" cy="26433"/>
                </a:xfrm>
                <a:custGeom>
                  <a:avLst/>
                  <a:gdLst>
                    <a:gd name="connsiteX0" fmla="*/ 0 w 250825"/>
                    <a:gd name="connsiteY0" fmla="*/ 0 h 79375"/>
                    <a:gd name="connsiteX1" fmla="*/ 117475 w 250825"/>
                    <a:gd name="connsiteY1" fmla="*/ 53975 h 79375"/>
                    <a:gd name="connsiteX2" fmla="*/ 250825 w 250825"/>
                    <a:gd name="connsiteY2" fmla="*/ 79375 h 79375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250825" h="79375">
                      <a:moveTo>
                        <a:pt x="0" y="0"/>
                      </a:moveTo>
                      <a:cubicBezTo>
                        <a:pt x="37835" y="20373"/>
                        <a:pt x="75671" y="40746"/>
                        <a:pt x="117475" y="53975"/>
                      </a:cubicBezTo>
                      <a:cubicBezTo>
                        <a:pt x="159279" y="67204"/>
                        <a:pt x="250825" y="79375"/>
                        <a:pt x="250825" y="79375"/>
                      </a:cubicBezTo>
                    </a:path>
                  </a:pathLst>
                </a:custGeom>
                <a:ln w="6350" cmpd="sng">
                  <a:solidFill>
                    <a:srgbClr val="000000"/>
                  </a:solidFill>
                  <a:headEnd type="none"/>
                  <a:tailEnd type="triangle" w="sm" len="sm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sp>
              <p:nvSpPr>
                <p:cNvPr id="27" name="Forma libre 26"/>
                <p:cNvSpPr/>
                <p:nvPr/>
              </p:nvSpPr>
              <p:spPr>
                <a:xfrm rot="5595025">
                  <a:off x="3658372" y="5012189"/>
                  <a:ext cx="120058" cy="93046"/>
                </a:xfrm>
                <a:custGeom>
                  <a:avLst/>
                  <a:gdLst>
                    <a:gd name="connsiteX0" fmla="*/ 20243 w 515543"/>
                    <a:gd name="connsiteY0" fmla="*/ 292204 h 292204"/>
                    <a:gd name="connsiteX1" fmla="*/ 7543 w 515543"/>
                    <a:gd name="connsiteY1" fmla="*/ 190604 h 292204"/>
                    <a:gd name="connsiteX2" fmla="*/ 121843 w 515543"/>
                    <a:gd name="connsiteY2" fmla="*/ 89004 h 292204"/>
                    <a:gd name="connsiteX3" fmla="*/ 312343 w 515543"/>
                    <a:gd name="connsiteY3" fmla="*/ 12804 h 292204"/>
                    <a:gd name="connsiteX4" fmla="*/ 515543 w 515543"/>
                    <a:gd name="connsiteY4" fmla="*/ 104 h 292204"/>
                    <a:gd name="connsiteX0" fmla="*/ 64351 w 508851"/>
                    <a:gd name="connsiteY0" fmla="*/ 279504 h 279504"/>
                    <a:gd name="connsiteX1" fmla="*/ 851 w 508851"/>
                    <a:gd name="connsiteY1" fmla="*/ 190604 h 279504"/>
                    <a:gd name="connsiteX2" fmla="*/ 115151 w 508851"/>
                    <a:gd name="connsiteY2" fmla="*/ 89004 h 279504"/>
                    <a:gd name="connsiteX3" fmla="*/ 305651 w 508851"/>
                    <a:gd name="connsiteY3" fmla="*/ 12804 h 279504"/>
                    <a:gd name="connsiteX4" fmla="*/ 508851 w 508851"/>
                    <a:gd name="connsiteY4" fmla="*/ 104 h 279504"/>
                    <a:gd name="connsiteX0" fmla="*/ 64986 w 509486"/>
                    <a:gd name="connsiteY0" fmla="*/ 279504 h 279504"/>
                    <a:gd name="connsiteX1" fmla="*/ 1486 w 509486"/>
                    <a:gd name="connsiteY1" fmla="*/ 190604 h 279504"/>
                    <a:gd name="connsiteX2" fmla="*/ 115786 w 509486"/>
                    <a:gd name="connsiteY2" fmla="*/ 89004 h 279504"/>
                    <a:gd name="connsiteX3" fmla="*/ 306286 w 509486"/>
                    <a:gd name="connsiteY3" fmla="*/ 12804 h 279504"/>
                    <a:gd name="connsiteX4" fmla="*/ 509486 w 509486"/>
                    <a:gd name="connsiteY4" fmla="*/ 104 h 279504"/>
                    <a:gd name="connsiteX0" fmla="*/ 64986 w 509486"/>
                    <a:gd name="connsiteY0" fmla="*/ 279400 h 279400"/>
                    <a:gd name="connsiteX1" fmla="*/ 1486 w 509486"/>
                    <a:gd name="connsiteY1" fmla="*/ 190500 h 279400"/>
                    <a:gd name="connsiteX2" fmla="*/ 115786 w 509486"/>
                    <a:gd name="connsiteY2" fmla="*/ 88900 h 279400"/>
                    <a:gd name="connsiteX3" fmla="*/ 306286 w 509486"/>
                    <a:gd name="connsiteY3" fmla="*/ 22225 h 279400"/>
                    <a:gd name="connsiteX4" fmla="*/ 509486 w 509486"/>
                    <a:gd name="connsiteY4" fmla="*/ 0 h 279400"/>
                    <a:gd name="connsiteX0" fmla="*/ 64986 w 509486"/>
                    <a:gd name="connsiteY0" fmla="*/ 267053 h 267053"/>
                    <a:gd name="connsiteX1" fmla="*/ 1486 w 509486"/>
                    <a:gd name="connsiteY1" fmla="*/ 178153 h 267053"/>
                    <a:gd name="connsiteX2" fmla="*/ 115786 w 509486"/>
                    <a:gd name="connsiteY2" fmla="*/ 76553 h 267053"/>
                    <a:gd name="connsiteX3" fmla="*/ 306286 w 509486"/>
                    <a:gd name="connsiteY3" fmla="*/ 9878 h 267053"/>
                    <a:gd name="connsiteX4" fmla="*/ 509486 w 509486"/>
                    <a:gd name="connsiteY4" fmla="*/ 353 h 267053"/>
                    <a:gd name="connsiteX0" fmla="*/ 64986 w 509486"/>
                    <a:gd name="connsiteY0" fmla="*/ 279400 h 279400"/>
                    <a:gd name="connsiteX1" fmla="*/ 1486 w 509486"/>
                    <a:gd name="connsiteY1" fmla="*/ 190500 h 279400"/>
                    <a:gd name="connsiteX2" fmla="*/ 115786 w 509486"/>
                    <a:gd name="connsiteY2" fmla="*/ 88900 h 279400"/>
                    <a:gd name="connsiteX3" fmla="*/ 306286 w 509486"/>
                    <a:gd name="connsiteY3" fmla="*/ 22225 h 279400"/>
                    <a:gd name="connsiteX4" fmla="*/ 509486 w 509486"/>
                    <a:gd name="connsiteY4" fmla="*/ 0 h 279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</a:cxnLst>
                  <a:rect l="l" t="t" r="r" b="b"/>
                  <a:pathLst>
                    <a:path w="509486" h="279400">
                      <a:moveTo>
                        <a:pt x="64986" y="279400"/>
                      </a:moveTo>
                      <a:cubicBezTo>
                        <a:pt x="21594" y="258233"/>
                        <a:pt x="-6981" y="222250"/>
                        <a:pt x="1486" y="190500"/>
                      </a:cubicBezTo>
                      <a:cubicBezTo>
                        <a:pt x="9953" y="158750"/>
                        <a:pt x="64986" y="116946"/>
                        <a:pt x="115786" y="88900"/>
                      </a:cubicBezTo>
                      <a:cubicBezTo>
                        <a:pt x="166586" y="60854"/>
                        <a:pt x="240669" y="37042"/>
                        <a:pt x="306286" y="22225"/>
                      </a:cubicBezTo>
                      <a:cubicBezTo>
                        <a:pt x="371903" y="7408"/>
                        <a:pt x="509486" y="0"/>
                        <a:pt x="509486" y="0"/>
                      </a:cubicBezTo>
                    </a:path>
                  </a:pathLst>
                </a:custGeom>
                <a:ln w="6350" cmpd="sng">
                  <a:solidFill>
                    <a:schemeClr val="tx1"/>
                  </a:solidFill>
                  <a:tailEnd w="sm" len="me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s-ES"/>
                </a:p>
              </p:txBody>
            </p:sp>
            <p:cxnSp>
              <p:nvCxnSpPr>
                <p:cNvPr id="28" name="Conector recto 27"/>
                <p:cNvCxnSpPr/>
                <p:nvPr/>
              </p:nvCxnSpPr>
              <p:spPr>
                <a:xfrm rot="16200000" flipV="1">
                  <a:off x="3730842" y="4930775"/>
                  <a:ext cx="2134" cy="377825"/>
                </a:xfrm>
                <a:prstGeom prst="line">
                  <a:avLst/>
                </a:prstGeom>
                <a:ln w="6350" cmpd="sng">
                  <a:solidFill>
                    <a:srgbClr val="000000"/>
                  </a:solidFill>
                  <a:prstDash val="solid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9" name="CuadroTexto 28"/>
            <p:cNvSpPr txBox="1"/>
            <p:nvPr/>
          </p:nvSpPr>
          <p:spPr>
            <a:xfrm>
              <a:off x="2692400" y="2908731"/>
              <a:ext cx="70058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 err="1">
                  <a:solidFill>
                    <a:srgbClr val="000000"/>
                  </a:solidFill>
                </a:rPr>
                <a:t>ZepA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i="1" dirty="0" err="1">
                  <a:solidFill>
                    <a:srgbClr val="000000"/>
                  </a:solidFill>
                </a:rPr>
                <a:t>Candidatus</a:t>
              </a:r>
              <a:r>
                <a:rPr lang="es-ES" sz="700" i="1" dirty="0">
                  <a:solidFill>
                    <a:srgbClr val="000000"/>
                  </a:solidFill>
                </a:rPr>
                <a:t> </a:t>
              </a:r>
              <a:r>
                <a:rPr lang="es-ES" sz="700" i="1" dirty="0" err="1">
                  <a:solidFill>
                    <a:srgbClr val="000000"/>
                  </a:solidFill>
                </a:rPr>
                <a:t>Nitrospira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dirty="0">
                  <a:solidFill>
                    <a:srgbClr val="000000"/>
                  </a:solidFill>
                </a:rPr>
                <a:t>(</a:t>
              </a:r>
              <a:r>
                <a:rPr lang="es-ES" sz="700" dirty="0" err="1">
                  <a:solidFill>
                    <a:srgbClr val="000000"/>
                  </a:solidFill>
                </a:rPr>
                <a:t>Nitrospirota</a:t>
              </a:r>
              <a:r>
                <a:rPr lang="es-ES" sz="700" dirty="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30" name="CuadroTexto 29"/>
            <p:cNvSpPr txBox="1"/>
            <p:nvPr/>
          </p:nvSpPr>
          <p:spPr>
            <a:xfrm>
              <a:off x="3549650" y="2908731"/>
              <a:ext cx="878339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 err="1">
                  <a:solidFill>
                    <a:srgbClr val="000000"/>
                  </a:solidFill>
                </a:rPr>
                <a:t>ZepA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i="1" dirty="0" err="1">
                  <a:solidFill>
                    <a:srgbClr val="000000"/>
                  </a:solidFill>
                </a:rPr>
                <a:t>Aquincola</a:t>
              </a:r>
              <a:r>
                <a:rPr lang="es-ES" sz="700" i="1" dirty="0">
                  <a:solidFill>
                    <a:srgbClr val="000000"/>
                  </a:solidFill>
                </a:rPr>
                <a:t> </a:t>
              </a:r>
              <a:r>
                <a:rPr lang="es-ES" sz="700" i="1" dirty="0" err="1">
                  <a:solidFill>
                    <a:srgbClr val="000000"/>
                  </a:solidFill>
                </a:rPr>
                <a:t>tertiaricarbonis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dirty="0">
                  <a:solidFill>
                    <a:srgbClr val="000000"/>
                  </a:solidFill>
                </a:rPr>
                <a:t>(</a:t>
              </a:r>
              <a:r>
                <a:rPr lang="es-ES" sz="700" dirty="0" err="1">
                  <a:solidFill>
                    <a:srgbClr val="000000"/>
                  </a:solidFill>
                </a:rPr>
                <a:t>Proteobacteria</a:t>
              </a:r>
              <a:r>
                <a:rPr lang="es-ES" sz="700" dirty="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31" name="CuadroTexto 30"/>
            <p:cNvSpPr txBox="1"/>
            <p:nvPr/>
          </p:nvSpPr>
          <p:spPr>
            <a:xfrm>
              <a:off x="4491664" y="2908731"/>
              <a:ext cx="915635" cy="523220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700" dirty="0" err="1">
                  <a:solidFill>
                    <a:srgbClr val="000000"/>
                  </a:solidFill>
                </a:rPr>
                <a:t>ZepA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i="1" dirty="0" err="1">
                  <a:solidFill>
                    <a:srgbClr val="000000"/>
                  </a:solidFill>
                </a:rPr>
                <a:t>Lacipirellula</a:t>
              </a:r>
              <a:endParaRPr lang="es-ES" sz="700" i="1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i="1" dirty="0" err="1">
                  <a:solidFill>
                    <a:srgbClr val="000000"/>
                  </a:solidFill>
                </a:rPr>
                <a:t>limnantheis</a:t>
              </a:r>
              <a:endParaRPr lang="es-ES" sz="700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dirty="0">
                  <a:solidFill>
                    <a:srgbClr val="000000"/>
                  </a:solidFill>
                </a:rPr>
                <a:t>(PVC </a:t>
              </a:r>
              <a:r>
                <a:rPr lang="es-ES" sz="700" dirty="0" err="1">
                  <a:solidFill>
                    <a:srgbClr val="000000"/>
                  </a:solidFill>
                </a:rPr>
                <a:t>superphylum</a:t>
              </a:r>
              <a:r>
                <a:rPr lang="es-ES" sz="700" dirty="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32" name="CuadroTexto 31"/>
            <p:cNvSpPr txBox="1"/>
            <p:nvPr/>
          </p:nvSpPr>
          <p:spPr>
            <a:xfrm>
              <a:off x="1708150" y="2908731"/>
              <a:ext cx="77596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00" dirty="0" err="1">
                  <a:solidFill>
                    <a:srgbClr val="000000"/>
                  </a:solidFill>
                </a:rPr>
                <a:t>ZepA</a:t>
              </a:r>
              <a:endParaRPr lang="es-ES" sz="700" dirty="0">
                <a:solidFill>
                  <a:srgbClr val="000000"/>
                </a:solidFill>
              </a:endParaRPr>
            </a:p>
            <a:p>
              <a:pPr algn="ctr"/>
              <a:r>
                <a:rPr lang="es-ES" sz="700" i="1" dirty="0" err="1">
                  <a:solidFill>
                    <a:srgbClr val="000000"/>
                  </a:solidFill>
                </a:rPr>
                <a:t>Anabaena</a:t>
              </a:r>
              <a:r>
                <a:rPr lang="es-ES" sz="700" i="1" dirty="0">
                  <a:solidFill>
                    <a:srgbClr val="000000"/>
                  </a:solidFill>
                </a:rPr>
                <a:t> </a:t>
              </a:r>
              <a:r>
                <a:rPr lang="es-ES" sz="700" i="1" dirty="0" err="1">
                  <a:solidFill>
                    <a:srgbClr val="000000"/>
                  </a:solidFill>
                </a:rPr>
                <a:t>sp</a:t>
              </a:r>
              <a:r>
                <a:rPr lang="es-ES" sz="700" i="1" dirty="0">
                  <a:solidFill>
                    <a:srgbClr val="000000"/>
                  </a:solidFill>
                </a:rPr>
                <a:t>. </a:t>
              </a:r>
              <a:r>
                <a:rPr lang="es-ES" sz="700" dirty="0">
                  <a:solidFill>
                    <a:srgbClr val="000000"/>
                  </a:solidFill>
                </a:rPr>
                <a:t>PCC 7120</a:t>
              </a:r>
            </a:p>
            <a:p>
              <a:pPr algn="ctr"/>
              <a:r>
                <a:rPr lang="es-ES" sz="700" dirty="0">
                  <a:solidFill>
                    <a:srgbClr val="000000"/>
                  </a:solidFill>
                </a:rPr>
                <a:t>(</a:t>
              </a:r>
              <a:r>
                <a:rPr lang="es-ES" sz="700" dirty="0" err="1">
                  <a:solidFill>
                    <a:srgbClr val="000000"/>
                  </a:solidFill>
                </a:rPr>
                <a:t>Cyanobacteria</a:t>
              </a:r>
              <a:r>
                <a:rPr lang="es-ES" sz="700" dirty="0">
                  <a:solidFill>
                    <a:srgbClr val="000000"/>
                  </a:solidFill>
                </a:rPr>
                <a:t>)</a:t>
              </a: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1332705" y="2152779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A</a:t>
              </a: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1332705" y="3747554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B</a:t>
              </a: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365115" y="7358999"/>
              <a:ext cx="2033377" cy="1350458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36" name="CuadroTexto 35"/>
            <p:cNvSpPr txBox="1"/>
            <p:nvPr/>
          </p:nvSpPr>
          <p:spPr>
            <a:xfrm>
              <a:off x="1332705" y="7497317"/>
              <a:ext cx="30684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C</a:t>
              </a: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3028976" y="8006310"/>
              <a:ext cx="3642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His44</a:t>
              </a: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3401645" y="7660712"/>
              <a:ext cx="3642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His53</a:t>
              </a: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3568753" y="7880109"/>
              <a:ext cx="3642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His55</a:t>
              </a: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3686737" y="8084909"/>
              <a:ext cx="37770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600" dirty="0"/>
                <a:t>Asp8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483607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06</TotalTime>
  <Words>109</Words>
  <Application>Microsoft Macintosh PowerPoint</Application>
  <PresentationFormat>A4 Paper (210x297 mm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PowerPoint Presentation</vt:lpstr>
    </vt:vector>
  </TitlesOfParts>
  <Company>IBV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uque Romero</dc:creator>
  <cp:lastModifiedBy>Ignacio Luque</cp:lastModifiedBy>
  <cp:revision>18</cp:revision>
  <dcterms:created xsi:type="dcterms:W3CDTF">2022-12-22T20:09:35Z</dcterms:created>
  <dcterms:modified xsi:type="dcterms:W3CDTF">2023-12-29T16:01:36Z</dcterms:modified>
</cp:coreProperties>
</file>